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1" d="100"/>
          <a:sy n="81" d="100"/>
        </p:scale>
        <p:origin x="-189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D11664-7808-8A46-A8FE-3AFEE2AEB360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8CD249-737D-B240-902A-ECFF6A79C22B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9473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2A. </a:t>
            </a:r>
            <a:r>
              <a:rPr lang="en-US" b="0" dirty="0" smtClean="0">
                <a:latin typeface="Times New Roman" pitchFamily="18" charset="0"/>
                <a:cs typeface="Times New Roman" pitchFamily="18" charset="0"/>
              </a:rPr>
              <a:t>Cellular Assembly and Organization,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 Molecular Transport, Amino Acid Metabolism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CD249-737D-B240-902A-ECFF6A79C22B}" type="slidenum">
              <a:rPr kumimoji="1" lang="zh-CN" altLang="en-US" smtClean="0"/>
              <a:pPr/>
              <a:t>2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2B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ell Signaling,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Cancer, Organismal Injury and Abnormalitie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CD249-737D-B240-902A-ECFF6A79C22B}" type="slidenum">
              <a:rPr kumimoji="1" lang="zh-CN" altLang="en-US" smtClean="0"/>
              <a:pPr/>
              <a:t>3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Figure 2C. 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Cellular Movement, Cellular Development, Tissue Development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CD249-737D-B240-902A-ECFF6A79C22B}" type="slidenum">
              <a:rPr kumimoji="1" lang="zh-CN" altLang="en-US" smtClean="0"/>
              <a:pPr/>
              <a:t>4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2D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ardiac Dysfunction,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Cardiovascular Disease, Heart Failure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CD249-737D-B240-902A-ECFF6A79C22B}" type="slidenum">
              <a:rPr kumimoji="1" lang="zh-CN" altLang="en-US" smtClean="0"/>
              <a:pPr/>
              <a:t>5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Figure 2E. 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Embryonic Development, Nervous System Development and Function, Organ Development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CD249-737D-B240-902A-ECFF6A79C22B}" type="slidenum">
              <a:rPr kumimoji="1" lang="zh-CN" altLang="en-US" smtClean="0"/>
              <a:pPr/>
              <a:t>6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baseline="0" smtClean="0">
                <a:latin typeface="Times New Roman" pitchFamily="18" charset="0"/>
                <a:cs typeface="Times New Roman" pitchFamily="18" charset="0"/>
              </a:rPr>
              <a:t>Figure 2F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Cellular Assembly and Organization, Lipid Metabolism, Small Molecule Biochemistry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CD249-737D-B240-902A-ECFF6A79C22B}" type="slidenum">
              <a:rPr kumimoji="1" lang="zh-CN" altLang="en-US" smtClean="0"/>
              <a:pPr/>
              <a:t>7</a:t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0587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23673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47434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2014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5536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9626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84982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7137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13129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3157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4424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9D570-11BE-1F4B-BF48-9E977818CE11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569F5-F597-D745-9F69-93491BA581D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2871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951430"/>
            <a:ext cx="8229600" cy="3174733"/>
          </a:xfrm>
        </p:spPr>
        <p:txBody>
          <a:bodyPr anchor="ctr">
            <a:normAutofit/>
          </a:bodyPr>
          <a:lstStyle/>
          <a:p>
            <a:pPr>
              <a:buNone/>
            </a:pPr>
            <a:r>
              <a:rPr lang="en-US" sz="1800" b="1" dirty="0" smtClean="0"/>
              <a:t>      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zh-CN" altLang="en-US" sz="1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800" b="1" dirty="0" smtClean="0">
                <a:latin typeface="Times New Roman" pitchFamily="18" charset="0"/>
                <a:cs typeface="Times New Roman" pitchFamily="18" charset="0"/>
              </a:rPr>
              <a:t>File</a:t>
            </a:r>
            <a:r>
              <a:rPr lang="zh-CN" altLang="en-US" sz="1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800" b="1" smtClean="0">
                <a:latin typeface="Times New Roman" pitchFamily="18" charset="0"/>
                <a:cs typeface="Times New Roman" pitchFamily="18" charset="0"/>
              </a:rPr>
              <a:t>16</a:t>
            </a:r>
            <a:r>
              <a:rPr lang="en-US" sz="1800" b="1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IPA Gene Network Analysis.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op gene networks for differentially expressed miRNAs (maturation/secretory)and their validated predicted gene target candidates were generated by IPA to show their directed interactions, with 140 (Panels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A-C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) and 70 (Panels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D-F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) molecules involved in each network.</a:t>
            </a:r>
            <a:endParaRPr lang="en-US" sz="1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G_140_network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1809" y="0"/>
            <a:ext cx="7000381" cy="6858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2A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G_140_network_2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9492" y="0"/>
            <a:ext cx="6905016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2B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G_140_network_3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220" y="0"/>
            <a:ext cx="7847559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2C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G_70_network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7754" y="0"/>
            <a:ext cx="5688491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2D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G_70_network_2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540" y="0"/>
            <a:ext cx="7848920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2E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G_70_network_3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3032" y="0"/>
            <a:ext cx="7237936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2F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155</Words>
  <Application>Microsoft Macintosh PowerPoint</Application>
  <PresentationFormat>全屏显示(4:3)</PresentationFormat>
  <Paragraphs>19</Paragraphs>
  <Slides>7</Slides>
  <Notes>6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feng Yin</dc:creator>
  <cp:lastModifiedBy>Kaifeng Yin</cp:lastModifiedBy>
  <cp:revision>23</cp:revision>
  <dcterms:created xsi:type="dcterms:W3CDTF">2014-06-26T22:33:06Z</dcterms:created>
  <dcterms:modified xsi:type="dcterms:W3CDTF">2014-07-24T23:15:44Z</dcterms:modified>
</cp:coreProperties>
</file>